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-90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cdc\Desktop\chip-seq\GO_term%20&amp;%20Pathway_comm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cdc\Desktop\chip-seq\GO_term%20&amp;%20Pathway_comm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stacked"/>
        <c:varyColors val="0"/>
        <c:ser>
          <c:idx val="0"/>
          <c:order val="0"/>
          <c:invertIfNegative val="0"/>
          <c:cat>
            <c:strRef>
              <c:f>DEC!$C$2:$C$7</c:f>
              <c:strCache>
                <c:ptCount val="6"/>
                <c:pt idx="0">
                  <c:v>Regulation of biological process</c:v>
                </c:pt>
                <c:pt idx="1">
                  <c:v>Regulation of cellular process</c:v>
                </c:pt>
                <c:pt idx="2">
                  <c:v>Biological regulation</c:v>
                </c:pt>
                <c:pt idx="3">
                  <c:v>Purinergic receptor signaling pathway</c:v>
                </c:pt>
                <c:pt idx="4">
                  <c:v>Intracellular signal transduction</c:v>
                </c:pt>
                <c:pt idx="5">
                  <c:v>Positive regulation of biological process</c:v>
                </c:pt>
              </c:strCache>
            </c:strRef>
          </c:cat>
          <c:val>
            <c:numRef>
              <c:f>DEC!$G$2:$G$7</c:f>
              <c:numCache>
                <c:formatCode>0.00_ </c:formatCode>
                <c:ptCount val="6"/>
                <c:pt idx="0">
                  <c:v>2.1938200260161143</c:v>
                </c:pt>
                <c:pt idx="1">
                  <c:v>2.1674910872937652</c:v>
                </c:pt>
                <c:pt idx="2">
                  <c:v>2.080921907623928</c:v>
                </c:pt>
                <c:pt idx="3">
                  <c:v>2.0757207139381184</c:v>
                </c:pt>
                <c:pt idx="4">
                  <c:v>1.5686362358410126</c:v>
                </c:pt>
                <c:pt idx="5">
                  <c:v>1.47108329972234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1473920"/>
        <c:axId val="81475456"/>
      </c:barChart>
      <c:catAx>
        <c:axId val="81473920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81475456"/>
        <c:crosses val="autoZero"/>
        <c:auto val="1"/>
        <c:lblAlgn val="ctr"/>
        <c:lblOffset val="100"/>
        <c:noMultiLvlLbl val="0"/>
      </c:catAx>
      <c:valAx>
        <c:axId val="81475456"/>
        <c:scaling>
          <c:orientation val="minMax"/>
        </c:scaling>
        <c:delete val="0"/>
        <c:axPos val="b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81473920"/>
        <c:crosses val="max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stacked"/>
        <c:varyColors val="0"/>
        <c:ser>
          <c:idx val="0"/>
          <c:order val="0"/>
          <c:invertIfNegative val="0"/>
          <c:cat>
            <c:strRef>
              <c:f>INC!$B$3:$B$8</c:f>
              <c:strCache>
                <c:ptCount val="6"/>
                <c:pt idx="0">
                  <c:v>Nucleic acid binding</c:v>
                </c:pt>
                <c:pt idx="1">
                  <c:v>Calcium activated cation channel activity</c:v>
                </c:pt>
                <c:pt idx="2">
                  <c:v>DNA binding</c:v>
                </c:pt>
                <c:pt idx="3">
                  <c:v>Zinc ion binding</c:v>
                </c:pt>
                <c:pt idx="4">
                  <c:v>Transition metal ion binding</c:v>
                </c:pt>
                <c:pt idx="5">
                  <c:v>Nucleus</c:v>
                </c:pt>
              </c:strCache>
            </c:strRef>
          </c:cat>
          <c:val>
            <c:numRef>
              <c:f>INC!$F$3:$F$8</c:f>
              <c:numCache>
                <c:formatCode>General</c:formatCode>
                <c:ptCount val="6"/>
                <c:pt idx="0">
                  <c:v>2.0555173278498313</c:v>
                </c:pt>
                <c:pt idx="1">
                  <c:v>2.0555173278498313</c:v>
                </c:pt>
                <c:pt idx="2">
                  <c:v>2.0555173278498313</c:v>
                </c:pt>
                <c:pt idx="3">
                  <c:v>2.0555173278498313</c:v>
                </c:pt>
                <c:pt idx="4">
                  <c:v>1.801342913045578</c:v>
                </c:pt>
                <c:pt idx="5">
                  <c:v>1.47366072261015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1486976"/>
        <c:axId val="81488512"/>
      </c:barChart>
      <c:catAx>
        <c:axId val="81486976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81488512"/>
        <c:crosses val="autoZero"/>
        <c:auto val="1"/>
        <c:lblAlgn val="ctr"/>
        <c:lblOffset val="100"/>
        <c:noMultiLvlLbl val="0"/>
      </c:catAx>
      <c:valAx>
        <c:axId val="81488512"/>
        <c:scaling>
          <c:orientation val="minMax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81486976"/>
        <c:crosses val="max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5350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91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2766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6556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2999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555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2082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1668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7652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0241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78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2A35D-D87A-4DD5-948B-1F9D17AD759A}" type="datetimeFigureOut">
              <a:rPr lang="ko-KR" altLang="en-US" smtClean="0"/>
              <a:t>2017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018E4-B83E-41BE-A710-BE5616A30F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33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1730468" y="570451"/>
            <a:ext cx="5114949" cy="2598786"/>
            <a:chOff x="1285852" y="1714488"/>
            <a:chExt cx="6643734" cy="3551164"/>
          </a:xfrm>
        </p:grpSpPr>
        <p:graphicFrame>
          <p:nvGraphicFramePr>
            <p:cNvPr id="5" name="차트 4"/>
            <p:cNvGraphicFramePr/>
            <p:nvPr>
              <p:extLst/>
            </p:nvPr>
          </p:nvGraphicFramePr>
          <p:xfrm>
            <a:off x="1285852" y="1714488"/>
            <a:ext cx="6643734" cy="33575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5143502" y="4929198"/>
              <a:ext cx="1652862" cy="336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-log</a:t>
              </a:r>
              <a:r>
                <a:rPr lang="en-US" altLang="ko-KR" sz="1000" baseline="-25000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10</a:t>
              </a:r>
              <a:r>
                <a:rPr lang="en-US" altLang="ko-KR" sz="1000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 (p-value)</a:t>
              </a:r>
              <a:endParaRPr lang="ko-KR" altLang="en-US" sz="1000" dirty="0">
                <a:latin typeface="Times New Roman" panose="02020603050405020304" pitchFamily="18" charset="0"/>
                <a:ea typeface="Arial Unicode MS" pitchFamily="50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54342" y="536895"/>
            <a:ext cx="587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79508" y="3491218"/>
            <a:ext cx="4949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667420" y="3491218"/>
            <a:ext cx="5110885" cy="2441351"/>
            <a:chOff x="1214414" y="1714488"/>
            <a:chExt cx="6181725" cy="3178039"/>
          </a:xfrm>
        </p:grpSpPr>
        <p:graphicFrame>
          <p:nvGraphicFramePr>
            <p:cNvPr id="10" name="차트 9"/>
            <p:cNvGraphicFramePr/>
            <p:nvPr>
              <p:extLst/>
            </p:nvPr>
          </p:nvGraphicFramePr>
          <p:xfrm>
            <a:off x="1214414" y="1714488"/>
            <a:ext cx="6181725" cy="29051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4929191" y="4572008"/>
              <a:ext cx="1492866" cy="3205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-log</a:t>
              </a:r>
              <a:r>
                <a:rPr lang="en-US" altLang="ko-KR" sz="1000" baseline="-25000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10</a:t>
              </a:r>
              <a:r>
                <a:rPr lang="en-US" altLang="ko-KR" sz="1000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 (p-value)</a:t>
              </a:r>
              <a:endParaRPr lang="ko-KR" altLang="en-US" sz="1000" dirty="0">
                <a:latin typeface="Times New Roman" panose="02020603050405020304" pitchFamily="18" charset="0"/>
                <a:ea typeface="Arial Unicode MS" pitchFamily="50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62985" y="6146828"/>
            <a:ext cx="71951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6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annotation of 38 Decreased (A) and 41 Increased (B) genes in chromosome 16, 17, 19, and 22 of HIV-1 latently infected cells using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Gestal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x-axis values are –log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aw p-value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1001" y="21835"/>
            <a:ext cx="2449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6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424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</TotalTime>
  <Words>6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cdc</dc:creator>
  <cp:lastModifiedBy>Balindan, Danica Joy</cp:lastModifiedBy>
  <cp:revision>9</cp:revision>
  <dcterms:created xsi:type="dcterms:W3CDTF">2016-10-26T04:56:54Z</dcterms:created>
  <dcterms:modified xsi:type="dcterms:W3CDTF">2017-05-05T18:53:02Z</dcterms:modified>
</cp:coreProperties>
</file>